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6858000" cy="9144000" type="letter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35"/>
    <p:restoredTop sz="94807"/>
  </p:normalViewPr>
  <p:slideViewPr>
    <p:cSldViewPr snapToGrid="0" snapToObjects="1">
      <p:cViewPr varScale="1">
        <p:scale>
          <a:sx n="93" d="100"/>
          <a:sy n="93" d="100"/>
        </p:scale>
        <p:origin x="343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F39BB6-8E07-EC49-98F9-E398AF662058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MX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EC5D5B-D510-C349-8F3F-67AA3A654E2C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0814849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448185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03550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63542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2261028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839787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056371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147630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876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44463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15416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035788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
Segundo nivel
Tercer nivel
Cuarto nivel
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285EE9-9C20-DB45-A82A-D6E587B3D880}" type="datetimeFigureOut">
              <a:rPr lang="es-MX" smtClean="0"/>
              <a:t>17/02/2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1FF22-A12A-2142-8A45-C7D41908F2A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849477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2348EFA-DC6C-DE43-85EF-B3B8045EBF9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624637" y="725953"/>
            <a:ext cx="5581015" cy="3737610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2F074810-3E35-EB40-8E5F-92D199D8B785}"/>
              </a:ext>
            </a:extLst>
          </p:cNvPr>
          <p:cNvSpPr txBox="1"/>
          <p:nvPr/>
        </p:nvSpPr>
        <p:spPr>
          <a:xfrm>
            <a:off x="624637" y="4690753"/>
            <a:ext cx="558101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KEGG mapping of cancer-related TFs identification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EGG network and relationship between enriched pathways which showed DETFs dependent of CDPs-exposure. Five genes (red boxes) were identified as biomarkers in cancer by transcriptional dysregulation (BCL6,  DDIT3, GADD45A, and HMGA2).</a:t>
            </a:r>
            <a:endParaRPr lang="es-MX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s-MX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56680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1</TotalTime>
  <Words>49</Words>
  <Application>Microsoft Macintosh PowerPoint</Application>
  <PresentationFormat>Carta (216 x 279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us Campos (UMSNH)</dc:creator>
  <cp:lastModifiedBy>Jesus Campos</cp:lastModifiedBy>
  <cp:revision>82</cp:revision>
  <cp:lastPrinted>2021-01-14T20:58:24Z</cp:lastPrinted>
  <dcterms:created xsi:type="dcterms:W3CDTF">2020-08-31T17:46:22Z</dcterms:created>
  <dcterms:modified xsi:type="dcterms:W3CDTF">2022-02-17T21:20:24Z</dcterms:modified>
</cp:coreProperties>
</file>